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6"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725"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DF08DFD-B7A8-4E8D-BBE3-578600B785C6}" type="datetimeFigureOut">
              <a:rPr lang="zh-CN" altLang="en-US" smtClean="0"/>
              <a:t>2022/2/25</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0FE4E0-EFA4-486B-9AE1-ABDBD63938E2}" type="slidenum">
              <a:rPr lang="zh-CN" altLang="en-US" smtClean="0"/>
              <a:t>‹#›</a:t>
            </a:fld>
            <a:endParaRPr lang="zh-CN" altLang="en-US"/>
          </a:p>
        </p:txBody>
      </p:sp>
    </p:spTree>
    <p:extLst>
      <p:ext uri="{BB962C8B-B14F-4D97-AF65-F5344CB8AC3E}">
        <p14:creationId xmlns:p14="http://schemas.microsoft.com/office/powerpoint/2010/main" val="6871542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FB0FE4E0-EFA4-486B-9AE1-ABDBD63938E2}" type="slidenum">
              <a:rPr lang="zh-CN" altLang="en-US" smtClean="0"/>
              <a:t>2</a:t>
            </a:fld>
            <a:endParaRPr lang="zh-CN" altLang="en-US"/>
          </a:p>
        </p:txBody>
      </p:sp>
    </p:spTree>
    <p:extLst>
      <p:ext uri="{BB962C8B-B14F-4D97-AF65-F5344CB8AC3E}">
        <p14:creationId xmlns:p14="http://schemas.microsoft.com/office/powerpoint/2010/main" val="2420019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F8FEF-7541-4F3E-A92E-86761B90A489}"/>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DB4CAC09-EF10-4CB8-BFED-5B17ED82FC4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857214C1-2280-4488-9135-80C79AC5E8B5}"/>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AF037A83-D032-4AA0-97B1-0BDAB6BCFAA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087D978-28FF-4B13-8EAB-4EF94F22C5DC}"/>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34134407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AC5F95A-F220-44E9-A572-9C4222DF507E}"/>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A8011EEE-8ADB-49B9-849D-62AAB1D67BBD}"/>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9C865581-308C-4A5A-B3AB-0D9D3D092913}"/>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1E5C8604-F321-43C8-8E77-1C81DA81C97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21443F4-B40A-46E5-8A73-D4EA6C262C20}"/>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22459406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E9603625-1DE5-4B1D-B035-B5807B0883C5}"/>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9307AFB3-6E60-4ED0-8A8B-087D53ECE345}"/>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A15514F2-7C41-4EDE-A39F-E8F210D79896}"/>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025FC96E-BEBD-4300-886B-EF7A5937317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7677F92-4151-4CB0-8F06-1BD968A6847D}"/>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4218161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F5A27FC-76BE-49AB-8571-E14D90B0B2D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DF4388A5-A3A4-4966-865D-EA5548E59E6C}"/>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0559CF46-7472-4193-A4C7-340722A9FF36}"/>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BB9C4720-E07C-4B1D-9C58-C36676941B2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5E2ECA9-DE31-4FE9-80DA-B8E35E2F5B7B}"/>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18578924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D500BDA-2ACF-4C93-A708-9694B752CB76}"/>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44D5E9E0-608E-47E9-B293-3EBDA166B9B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CFFC4CCB-9BB0-474D-A687-62F9720FED0D}"/>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5BC74F5E-6FEE-409D-A7FA-AA062F97CB2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058BE21-DD6E-4377-8025-D0EBB142435F}"/>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10310908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35702CE-30D1-4ECE-B0DD-E67980AFDECB}"/>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00FD0FE9-E9F1-4843-8C1D-512B9563ACC6}"/>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3AA300EB-8516-4CB9-A4C8-8E8289EA3033}"/>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1C17BBC9-8433-46FD-B38E-1CACF3A852FA}"/>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6" name="页脚占位符 5">
            <a:extLst>
              <a:ext uri="{FF2B5EF4-FFF2-40B4-BE49-F238E27FC236}">
                <a16:creationId xmlns:a16="http://schemas.microsoft.com/office/drawing/2014/main" id="{38B2AAB5-A46D-4ED3-8A1C-6D00A283D740}"/>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A2C3891-93E4-4743-8C1D-58DF1A8BD467}"/>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3770676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6337E33-754A-4EA2-8585-C1D39933AA3E}"/>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DFEED8C2-E03E-4CC2-B410-9F39509760E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792F0B8B-DEB7-44C4-B0C1-6AC9AC5CB3EB}"/>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79DD3BA5-08DE-491C-884F-0A33F6C122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A5434E1D-B341-43CA-AC89-5A25C85134ED}"/>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0398BBEC-E37B-4116-8E6C-D0D40BAD04ED}"/>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8" name="页脚占位符 7">
            <a:extLst>
              <a:ext uri="{FF2B5EF4-FFF2-40B4-BE49-F238E27FC236}">
                <a16:creationId xmlns:a16="http://schemas.microsoft.com/office/drawing/2014/main" id="{11002B16-79BF-494B-BEF4-692F5FEA949B}"/>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332471E7-E6F5-4EBB-9A9E-FF36B992E711}"/>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28816497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A3EE43F-4A09-499B-96AC-F39EEA9EB029}"/>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7FBB0DA2-63F9-4B00-B49B-B4882A4505A4}"/>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4" name="页脚占位符 3">
            <a:extLst>
              <a:ext uri="{FF2B5EF4-FFF2-40B4-BE49-F238E27FC236}">
                <a16:creationId xmlns:a16="http://schemas.microsoft.com/office/drawing/2014/main" id="{5944DB9D-A49F-4978-A7A5-C61C1FFF50AD}"/>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D65C9A57-5370-4D43-9E2F-C8A9C044451F}"/>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23937180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5B768874-B57E-4F62-87A0-B942317FE690}"/>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3" name="页脚占位符 2">
            <a:extLst>
              <a:ext uri="{FF2B5EF4-FFF2-40B4-BE49-F238E27FC236}">
                <a16:creationId xmlns:a16="http://schemas.microsoft.com/office/drawing/2014/main" id="{9C9823AE-9D63-4F31-89EA-266AB17C2D96}"/>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DB3A5190-0E68-4D7C-A3DF-1A65ED7F37D7}"/>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3020411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3FD7D0D-21FF-429E-9D07-A00C4128A36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A99DD240-5067-47D5-8907-382924E10FA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5D755505-0DAB-4FF5-AF36-64F9ABCD3F3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7A664CC1-A1DE-4512-9462-872EF3D76AB7}"/>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6" name="页脚占位符 5">
            <a:extLst>
              <a:ext uri="{FF2B5EF4-FFF2-40B4-BE49-F238E27FC236}">
                <a16:creationId xmlns:a16="http://schemas.microsoft.com/office/drawing/2014/main" id="{387A5940-4F6D-426F-A1CE-78C9A2F78B9D}"/>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CBC1761B-BEF1-43D1-AC5F-B8457AA8A23F}"/>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34097370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A611C5C-CD2D-4C18-8C3E-F2C1D76D292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3B1FE283-DF01-49A0-822D-DD81E384E72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9C72B004-9AC5-4641-8F53-641E1B005B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AC922CEC-19E3-433A-B488-2983F6B586D1}"/>
              </a:ext>
            </a:extLst>
          </p:cNvPr>
          <p:cNvSpPr>
            <a:spLocks noGrp="1"/>
          </p:cNvSpPr>
          <p:nvPr>
            <p:ph type="dt" sz="half" idx="10"/>
          </p:nvPr>
        </p:nvSpPr>
        <p:spPr/>
        <p:txBody>
          <a:bodyPr/>
          <a:lstStyle/>
          <a:p>
            <a:fld id="{9D7FD190-BB8D-4564-B7C3-8C5D629BE18A}" type="datetimeFigureOut">
              <a:rPr lang="zh-CN" altLang="en-US" smtClean="0"/>
              <a:t>2022/2/25</a:t>
            </a:fld>
            <a:endParaRPr lang="zh-CN" altLang="en-US"/>
          </a:p>
        </p:txBody>
      </p:sp>
      <p:sp>
        <p:nvSpPr>
          <p:cNvPr id="6" name="页脚占位符 5">
            <a:extLst>
              <a:ext uri="{FF2B5EF4-FFF2-40B4-BE49-F238E27FC236}">
                <a16:creationId xmlns:a16="http://schemas.microsoft.com/office/drawing/2014/main" id="{0807B283-224B-4986-8A94-8201B033F5E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A2B9E7A-7AD2-42E0-95A6-720E4AF9022E}"/>
              </a:ext>
            </a:extLst>
          </p:cNvPr>
          <p:cNvSpPr>
            <a:spLocks noGrp="1"/>
          </p:cNvSpPr>
          <p:nvPr>
            <p:ph type="sldNum" sz="quarter" idx="12"/>
          </p:nvPr>
        </p:nvSpPr>
        <p:spPr/>
        <p:txBody>
          <a:body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2015216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0FB174C7-9898-40DD-B46A-9012AE04B98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A7B2420-B9F4-4204-9FD9-CE7F3BAFD05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ED33130-C354-4B68-9CE2-C4CEE522A35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D7FD190-BB8D-4564-B7C3-8C5D629BE18A}" type="datetimeFigureOut">
              <a:rPr lang="zh-CN" altLang="en-US" smtClean="0"/>
              <a:t>2022/2/25</a:t>
            </a:fld>
            <a:endParaRPr lang="zh-CN" altLang="en-US"/>
          </a:p>
        </p:txBody>
      </p:sp>
      <p:sp>
        <p:nvSpPr>
          <p:cNvPr id="5" name="页脚占位符 4">
            <a:extLst>
              <a:ext uri="{FF2B5EF4-FFF2-40B4-BE49-F238E27FC236}">
                <a16:creationId xmlns:a16="http://schemas.microsoft.com/office/drawing/2014/main" id="{F6F2F94D-65AA-4908-B8A4-BA07ECB16FB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73DD66A-73BC-49EA-8942-A72EE20E62D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D3E3924-7376-4BAC-B36C-738BCDD252AC}" type="slidenum">
              <a:rPr lang="zh-CN" altLang="en-US" smtClean="0"/>
              <a:t>‹#›</a:t>
            </a:fld>
            <a:endParaRPr lang="zh-CN" altLang="en-US"/>
          </a:p>
        </p:txBody>
      </p:sp>
    </p:spTree>
    <p:extLst>
      <p:ext uri="{BB962C8B-B14F-4D97-AF65-F5344CB8AC3E}">
        <p14:creationId xmlns:p14="http://schemas.microsoft.com/office/powerpoint/2010/main" val="4203270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内容占位符 4">
            <a:extLst>
              <a:ext uri="{FF2B5EF4-FFF2-40B4-BE49-F238E27FC236}">
                <a16:creationId xmlns:a16="http://schemas.microsoft.com/office/drawing/2014/main" id="{3F4AC18F-4236-4DC9-BC4F-1E58733E8BEF}"/>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648386" y="978190"/>
            <a:ext cx="4756684" cy="4351338"/>
          </a:xfrm>
        </p:spPr>
      </p:pic>
      <p:sp>
        <p:nvSpPr>
          <p:cNvPr id="2" name="标题 1">
            <a:extLst>
              <a:ext uri="{FF2B5EF4-FFF2-40B4-BE49-F238E27FC236}">
                <a16:creationId xmlns:a16="http://schemas.microsoft.com/office/drawing/2014/main" id="{1824AB62-0182-4FC8-B531-A8A5E182EF10}"/>
              </a:ext>
            </a:extLst>
          </p:cNvPr>
          <p:cNvSpPr>
            <a:spLocks noGrp="1"/>
          </p:cNvSpPr>
          <p:nvPr>
            <p:ph type="title"/>
          </p:nvPr>
        </p:nvSpPr>
        <p:spPr>
          <a:xfrm>
            <a:off x="838200" y="4975701"/>
            <a:ext cx="10515600" cy="1325563"/>
          </a:xfrm>
        </p:spPr>
        <p:txBody>
          <a:bodyPr>
            <a:noAutofit/>
          </a:bodyPr>
          <a:lstStyle/>
          <a:p>
            <a:pPr algn="just">
              <a:lnSpc>
                <a:spcPct val="10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ure S1. </a:t>
            </a:r>
            <a:r>
              <a:rPr lang="en-US" altLang="zh-CN" sz="1400" dirty="0">
                <a:solidFill>
                  <a:srgbClr val="333333"/>
                </a:solidFill>
                <a:latin typeface="Times New Roman" panose="02020603050405020304" pitchFamily="18" charset="0"/>
                <a:cs typeface="Times New Roman" panose="02020603050405020304" pitchFamily="18" charset="0"/>
              </a:rPr>
              <a:t>Beta-diversity levels of bacterial communities. (A) The </a:t>
            </a:r>
            <a:r>
              <a:rPr lang="en-US" altLang="zh-CN" sz="1400" dirty="0" err="1">
                <a:solidFill>
                  <a:srgbClr val="333333"/>
                </a:solidFill>
                <a:latin typeface="Times New Roman" panose="02020603050405020304" pitchFamily="18" charset="0"/>
                <a:cs typeface="Times New Roman" panose="02020603050405020304" pitchFamily="18" charset="0"/>
              </a:rPr>
              <a:t>PCoAs</a:t>
            </a:r>
            <a:r>
              <a:rPr lang="en-US" altLang="zh-CN" sz="1400" dirty="0">
                <a:solidFill>
                  <a:srgbClr val="333333"/>
                </a:solidFill>
                <a:latin typeface="Times New Roman" panose="02020603050405020304" pitchFamily="18" charset="0"/>
                <a:cs typeface="Times New Roman" panose="02020603050405020304" pitchFamily="18" charset="0"/>
              </a:rPr>
              <a:t> of bacteria. Soil type is the main source of bacterial community changes, and each spot corresponds to different soil-type samples. (B-D) Significance test analysis of bacteria. The ends of the line represent the minimum and maximum values, and the line in the box is the middle value. H1, H2, and H3, normal, normal + 20%, and normal + 40% nitrogen fertilizer concentrations, respectively. F, filter membrane present, and NF, no filter membrane. </a:t>
            </a:r>
            <a:endParaRPr lang="zh-CN" altLang="en-US" sz="1400" dirty="0">
              <a:solidFill>
                <a:srgbClr val="333333"/>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793516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BAB91C0-58F9-4C4D-932F-748F80EA1DAC}"/>
              </a:ext>
            </a:extLst>
          </p:cNvPr>
          <p:cNvSpPr>
            <a:spLocks noGrp="1"/>
          </p:cNvSpPr>
          <p:nvPr>
            <p:ph type="ctrTitle"/>
          </p:nvPr>
        </p:nvSpPr>
        <p:spPr/>
        <p:txBody>
          <a:bodyPr/>
          <a:lstStyle/>
          <a:p>
            <a:endParaRPr lang="zh-CN" altLang="en-US"/>
          </a:p>
        </p:txBody>
      </p:sp>
      <p:sp>
        <p:nvSpPr>
          <p:cNvPr id="3" name="副标题 2">
            <a:extLst>
              <a:ext uri="{FF2B5EF4-FFF2-40B4-BE49-F238E27FC236}">
                <a16:creationId xmlns:a16="http://schemas.microsoft.com/office/drawing/2014/main" id="{FF7BC2E9-FE54-44BA-8A19-EBD73D65BB6C}"/>
              </a:ext>
            </a:extLst>
          </p:cNvPr>
          <p:cNvSpPr>
            <a:spLocks noGrp="1"/>
          </p:cNvSpPr>
          <p:nvPr>
            <p:ph type="subTitle" idx="1"/>
          </p:nvPr>
        </p:nvSpPr>
        <p:spPr/>
        <p:txBody>
          <a:bodyPr/>
          <a:lstStyle/>
          <a:p>
            <a:endParaRPr lang="zh-CN" altLang="en-US"/>
          </a:p>
        </p:txBody>
      </p:sp>
      <p:pic>
        <p:nvPicPr>
          <p:cNvPr id="7" name="图片 6">
            <a:extLst>
              <a:ext uri="{FF2B5EF4-FFF2-40B4-BE49-F238E27FC236}">
                <a16:creationId xmlns:a16="http://schemas.microsoft.com/office/drawing/2014/main" id="{A3DCDF0B-DE05-4E26-A09E-EAEC453D00D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864670"/>
            <a:ext cx="12192000" cy="5249946"/>
          </a:xfrm>
          <a:prstGeom prst="rect">
            <a:avLst/>
          </a:prstGeom>
        </p:spPr>
      </p:pic>
      <p:sp>
        <p:nvSpPr>
          <p:cNvPr id="5" name="标题 1">
            <a:extLst>
              <a:ext uri="{FF2B5EF4-FFF2-40B4-BE49-F238E27FC236}">
                <a16:creationId xmlns:a16="http://schemas.microsoft.com/office/drawing/2014/main" id="{93621AF2-5F4F-4C58-975D-51A83B9BDDBC}"/>
              </a:ext>
            </a:extLst>
          </p:cNvPr>
          <p:cNvSpPr txBox="1">
            <a:spLocks/>
          </p:cNvSpPr>
          <p:nvPr/>
        </p:nvSpPr>
        <p:spPr>
          <a:xfrm>
            <a:off x="706120" y="4614783"/>
            <a:ext cx="10515600" cy="1458119"/>
          </a:xfrm>
          <a:prstGeom prst="rect">
            <a:avLst/>
          </a:prstGeom>
        </p:spPr>
        <p:txBody>
          <a:bodyPr vert="horz" lIns="91440" tIns="45720" rIns="91440" bIns="45720" rtlCol="0" anchor="b">
            <a:normAutofit fontScale="975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just">
              <a:lnSpc>
                <a:spcPct val="100000"/>
              </a:lnSpc>
            </a:pPr>
            <a:r>
              <a:rPr lang="en-US" altLang="zh-CN" sz="1400" b="1" kern="100" dirty="0">
                <a:solidFill>
                  <a:srgbClr val="000000"/>
                </a:solidFill>
                <a:latin typeface="Times New Roman" panose="02020603050405020304" pitchFamily="18" charset="0"/>
                <a:cs typeface="Times New Roman" panose="02020603050405020304" pitchFamily="18" charset="0"/>
              </a:rPr>
              <a:t>Figure S2. </a:t>
            </a:r>
            <a:r>
              <a:rPr lang="en-US" altLang="zh-CN" sz="1400" b="0" i="0" dirty="0">
                <a:effectLst/>
                <a:latin typeface="Times New Roman" panose="02020603050405020304" pitchFamily="18" charset="0"/>
                <a:cs typeface="Times New Roman" panose="02020603050405020304" pitchFamily="18" charset="0"/>
              </a:rPr>
              <a:t>The relative abundances of the top 20 classes of the most abundant bacteria plotted as a functional heatmap in soil without plants (A) and with plants (B) . H1, H2, and H3, normal, normal + 20%, and normal + 40% nitrogen fertilizer concentrations, respectively. F, filter membrane present, and NF, no filter membrane. </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48140642"/>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TotalTime>
  <Words>179</Words>
  <Application>Microsoft Office PowerPoint</Application>
  <PresentationFormat>宽屏</PresentationFormat>
  <Paragraphs>3</Paragraphs>
  <Slides>2</Slides>
  <Notes>1</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2</vt:i4>
      </vt:variant>
    </vt:vector>
  </HeadingPairs>
  <TitlesOfParts>
    <vt:vector size="7" baseType="lpstr">
      <vt:lpstr>等线</vt:lpstr>
      <vt:lpstr>等线 Light</vt:lpstr>
      <vt:lpstr>Arial</vt:lpstr>
      <vt:lpstr>Times New Roman</vt:lpstr>
      <vt:lpstr>Office 主题​​</vt:lpstr>
      <vt:lpstr>Figure S1. Beta-diversity levels of bacterial communities. (A) The PCoAs of bacteria. Soil type is the main source of bacterial community changes, and each spot corresponds to different soil-type samples. (B-D) Significance test analysis of bacteria. The ends of the line represent the minimum and maximum values, and the line in the box is the middle value. H1, H2, and H3, normal, normal + 20%, and normal + 40% nitrogen fertilizer concentrations, respectively. F, filter membrane present, and NF, no filter membrane. </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夏 琦妮</dc:creator>
  <cp:lastModifiedBy>91789</cp:lastModifiedBy>
  <cp:revision>15</cp:revision>
  <dcterms:created xsi:type="dcterms:W3CDTF">2022-01-10T03:51:13Z</dcterms:created>
  <dcterms:modified xsi:type="dcterms:W3CDTF">2022-02-25T00:38:16Z</dcterms:modified>
</cp:coreProperties>
</file>